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erat Bagha" initials="MB" lastIdx="7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B0A5"/>
    <a:srgbClr val="2F5597"/>
    <a:srgbClr val="007098"/>
    <a:srgbClr val="FFC000"/>
    <a:srgbClr val="E6E6E6"/>
    <a:srgbClr val="00B050"/>
    <a:srgbClr val="0C5882"/>
    <a:srgbClr val="0B5882"/>
    <a:srgbClr val="007097"/>
    <a:srgbClr val="FFD96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50" d="100"/>
          <a:sy n="150" d="100"/>
        </p:scale>
        <p:origin x="-112" y="-55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commentAuthors" Target="commentAuthors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1B3A52-9C11-DE48-8CC0-104A647BC746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895EF6-8338-224C-8731-9E89DD4A1B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75809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E0605837-44FE-4697-A465-ED5A13A929B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DB815682-DA19-4813-AD13-4EC0E644810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16834218-596C-46D8-8157-9050CC141E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D2D111F2-9794-486E-90E2-63D5D67E66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8258C388-3162-4C73-A1C6-0C75695F09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9197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660DC4C4-FE14-4460-8232-F04345519E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865F2FB6-87E8-43CE-A50E-707DA4F6C4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11BBEAD2-75C4-47FB-939C-32535B3B38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17CEBC50-A90E-4F43-ADB4-258787EB31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7B6021C3-ECF0-4126-A815-298067FB41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1242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0B6D50D9-819A-43F1-A92F-C7BF3A538C4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B374FDFA-E6F6-4812-BACA-6E54FE4D74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28B9E568-8CB5-45DC-8E8A-9EDC71C6A9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F373664B-7588-4585-BD0C-1E6E11D027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5FC39804-BA91-4EA1-80E1-6BB89904CC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2145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DD65E8AD-FEC3-46A1-9F7F-525FFB3331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C09381BB-97E5-4DE6-B969-FAF52D16C51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FB3C86E2-A2EF-4601-BFDB-31B0FEF1C4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BFFC0143-D542-4E5F-9773-301F1BD57E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4B6FC666-DFBD-448D-B7CE-04E5DF7032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153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99CB79B4-D0B3-4B86-A059-94B712EC51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876AB63C-6A3C-4E17-836A-5F006C416D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5319F62D-10B6-4C87-AAD7-75185A43BA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053764DF-2E6A-48B1-A782-1133B1FB25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0191A2BF-A193-43FE-BD09-C21FD079AB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3019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E06F5658-FB35-4144-8BD4-74EEB671DD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F72B149B-3C2A-4FB5-A239-1D7D8F7229A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A5BCC1F6-0FF7-4A2C-A584-2242DC21FC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E18F72D4-66EB-4D65-B6CB-C5893BBF42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E1FA55F2-32F4-4CB7-B59E-B20D768006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26B707D9-514F-43C1-9166-681A55DBAC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0137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D5E1F58B-E858-4F5A-8307-E25749AA06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948945E2-A55C-4EF4-99A5-E9D94C2C83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94D21E10-4E4A-4A9B-8665-CC047E7902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714CC3FC-2497-409F-8AC3-61293C5ABF9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E6C7CB3D-6B75-457C-8C17-721BA068A3F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AEDC7E2F-B0D5-464A-BE2C-29C3B56D83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83EF950B-3973-427A-AE34-5CED434A02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D6C1A0E0-4B27-4E11-AA50-1CCFA4B771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948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8198F535-A3A4-4082-92F6-3DE35B2002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05710233-981B-4341-9BDC-B036BF537C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AE97D9FD-BA35-45C3-9FD6-46C4269441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38DC67DE-2F0B-4B18-8F06-9EDDF18FF2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9064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EB8F7090-1EE7-47F3-B760-2C61F9D74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0B690DB5-9534-4AD8-8550-0DBCB427B7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15480695-A8C6-4615-818D-A068CB5D3C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5419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DCFD880-C7BC-4A9F-9284-51D0CC1018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1F52F9D1-E005-4C9B-9E13-AFDF44196B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6F2F25E1-1CDE-4434-8B92-53DDA6B2C9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0F8016F1-B9EF-4838-A85C-74986DCC5C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431C4F04-F159-453E-A6B9-B55DFBD56F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2E565885-8DD0-4ABA-82EA-FD85906A9B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481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F2502AA-F3DC-4104-92FF-0DA5A51935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591FE64B-A526-465E-A981-B0BAC54252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74E23C09-CF58-42B5-A10F-7B10E1DE0C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D4E10560-47AE-4258-B707-72DDCF552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D8BC694B-5031-4723-B9A3-F1179FCECB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AF0E08D3-B771-4554-A70D-47A5503454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248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376867A7-BD58-4E51-95DB-58B88D079A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D3A05465-645A-4AC0-B322-1A4891808D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3171DFF0-7F94-4D7A-AEDE-45F3DFCD42F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8DCA8706-B7AA-43F1-A378-8AA892861D0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66FEA253-09BA-41BF-ADCE-61F3048022A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8186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4" name="Straight Connector 53"/>
          <p:cNvCxnSpPr/>
          <p:nvPr/>
        </p:nvCxnSpPr>
        <p:spPr>
          <a:xfrm>
            <a:off x="5801880" y="5347254"/>
            <a:ext cx="575" cy="21788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5809279" y="4093032"/>
            <a:ext cx="575" cy="21788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/>
          <p:cNvCxnSpPr/>
          <p:nvPr/>
        </p:nvCxnSpPr>
        <p:spPr>
          <a:xfrm flipH="1">
            <a:off x="3666880" y="5525925"/>
            <a:ext cx="42901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/>
          <p:cNvCxnSpPr/>
          <p:nvPr/>
        </p:nvCxnSpPr>
        <p:spPr>
          <a:xfrm flipV="1">
            <a:off x="3979090" y="3347289"/>
            <a:ext cx="234494" cy="14215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/>
          <p:cNvCxnSpPr/>
          <p:nvPr/>
        </p:nvCxnSpPr>
        <p:spPr>
          <a:xfrm>
            <a:off x="2907629" y="3374143"/>
            <a:ext cx="219432" cy="13249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>
            <a:stCxn id="10" idx="3"/>
          </p:cNvCxnSpPr>
          <p:nvPr/>
        </p:nvCxnSpPr>
        <p:spPr>
          <a:xfrm>
            <a:off x="2893195" y="1906422"/>
            <a:ext cx="260138" cy="19717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3988749" y="2716846"/>
            <a:ext cx="199136" cy="10258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 flipH="1">
            <a:off x="4716372" y="2383664"/>
            <a:ext cx="49843" cy="19162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 flipH="1">
            <a:off x="8550593" y="3530782"/>
            <a:ext cx="207072" cy="11165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 flipH="1" flipV="1">
            <a:off x="7386806" y="3357538"/>
            <a:ext cx="199542" cy="9327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 flipH="1">
            <a:off x="6950693" y="2205001"/>
            <a:ext cx="22373" cy="33324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 flipH="1">
            <a:off x="7388934" y="2683045"/>
            <a:ext cx="207072" cy="11165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 flipH="1">
            <a:off x="6304538" y="3344580"/>
            <a:ext cx="209774" cy="89627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 flipV="1">
            <a:off x="5094587" y="3339751"/>
            <a:ext cx="221316" cy="869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 flipH="1" flipV="1">
            <a:off x="6321029" y="4955350"/>
            <a:ext cx="260888" cy="93771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Oval 1"/>
          <p:cNvSpPr>
            <a:spLocks noChangeAspect="1"/>
          </p:cNvSpPr>
          <p:nvPr/>
        </p:nvSpPr>
        <p:spPr>
          <a:xfrm>
            <a:off x="4108283" y="2564067"/>
            <a:ext cx="1079999" cy="1079999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none" lIns="0" tIns="0" rIns="0" bIns="0" rtlCol="0" anchor="ctr"/>
          <a:lstStyle/>
          <a:p>
            <a:pPr algn="ctr"/>
            <a:r>
              <a:rPr lang="en-GB" sz="1100">
                <a:solidFill>
                  <a:schemeClr val="tx1"/>
                </a:solidFill>
                <a:latin typeface="Arial"/>
                <a:cs typeface="Arial"/>
              </a:rPr>
              <a:t>Opportunities</a:t>
            </a:r>
          </a:p>
        </p:txBody>
      </p:sp>
      <p:sp>
        <p:nvSpPr>
          <p:cNvPr id="3" name="Oval 2"/>
          <p:cNvSpPr>
            <a:spLocks noChangeAspect="1"/>
          </p:cNvSpPr>
          <p:nvPr/>
        </p:nvSpPr>
        <p:spPr>
          <a:xfrm>
            <a:off x="6425180" y="2543079"/>
            <a:ext cx="1080000" cy="1080000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>
                <a:solidFill>
                  <a:srgbClr val="000000"/>
                </a:solidFill>
                <a:latin typeface="Arial"/>
                <a:cs typeface="Arial"/>
              </a:rPr>
              <a:t>Challenges</a:t>
            </a:r>
          </a:p>
        </p:txBody>
      </p:sp>
      <p:sp>
        <p:nvSpPr>
          <p:cNvPr id="4" name="Oval 3"/>
          <p:cNvSpPr>
            <a:spLocks noChangeAspect="1"/>
          </p:cNvSpPr>
          <p:nvPr/>
        </p:nvSpPr>
        <p:spPr>
          <a:xfrm>
            <a:off x="5262593" y="3035346"/>
            <a:ext cx="1080000" cy="1080000"/>
          </a:xfrm>
          <a:prstGeom prst="ellipse">
            <a:avLst/>
          </a:prstGeom>
          <a:solidFill>
            <a:srgbClr val="FFC000">
              <a:alpha val="49804"/>
            </a:srgb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 b="1" dirty="0">
                <a:solidFill>
                  <a:srgbClr val="000000"/>
                </a:solidFill>
                <a:latin typeface="Arial"/>
                <a:cs typeface="Arial"/>
              </a:rPr>
              <a:t>Nurses</a:t>
            </a:r>
          </a:p>
        </p:txBody>
      </p:sp>
      <p:sp>
        <p:nvSpPr>
          <p:cNvPr id="5" name="Oval 4"/>
          <p:cNvSpPr>
            <a:spLocks noChangeAspect="1"/>
          </p:cNvSpPr>
          <p:nvPr/>
        </p:nvSpPr>
        <p:spPr>
          <a:xfrm>
            <a:off x="5270679" y="4294265"/>
            <a:ext cx="1080000" cy="1080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 dirty="0">
                <a:solidFill>
                  <a:srgbClr val="000000"/>
                </a:solidFill>
                <a:latin typeface="Arial"/>
                <a:cs typeface="Arial"/>
              </a:rPr>
              <a:t>eHealth Tools</a:t>
            </a:r>
          </a:p>
        </p:txBody>
      </p:sp>
      <p:sp>
        <p:nvSpPr>
          <p:cNvPr id="6" name="Oval 5"/>
          <p:cNvSpPr>
            <a:spLocks noChangeAspect="1"/>
          </p:cNvSpPr>
          <p:nvPr/>
        </p:nvSpPr>
        <p:spPr>
          <a:xfrm>
            <a:off x="4308597" y="1330719"/>
            <a:ext cx="1080000" cy="1080000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>
                <a:solidFill>
                  <a:srgbClr val="000000"/>
                </a:solidFill>
                <a:latin typeface="Arial"/>
                <a:cs typeface="Arial"/>
              </a:rPr>
              <a:t>Education</a:t>
            </a:r>
          </a:p>
        </p:txBody>
      </p:sp>
      <p:sp>
        <p:nvSpPr>
          <p:cNvPr id="7" name="Oval 6"/>
          <p:cNvSpPr>
            <a:spLocks noChangeAspect="1"/>
          </p:cNvSpPr>
          <p:nvPr/>
        </p:nvSpPr>
        <p:spPr>
          <a:xfrm>
            <a:off x="3019402" y="1908035"/>
            <a:ext cx="1080000" cy="1080000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>
                <a:solidFill>
                  <a:srgbClr val="000000"/>
                </a:solidFill>
                <a:latin typeface="Arial"/>
                <a:cs typeface="Arial"/>
              </a:rPr>
              <a:t>Clinical/ Diagnostic</a:t>
            </a:r>
          </a:p>
        </p:txBody>
      </p:sp>
      <p:sp>
        <p:nvSpPr>
          <p:cNvPr id="8" name="Oval 7"/>
          <p:cNvSpPr>
            <a:spLocks noChangeAspect="1"/>
          </p:cNvSpPr>
          <p:nvPr/>
        </p:nvSpPr>
        <p:spPr>
          <a:xfrm>
            <a:off x="3019404" y="3206990"/>
            <a:ext cx="1080000" cy="1080000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>
                <a:solidFill>
                  <a:srgbClr val="000000"/>
                </a:solidFill>
                <a:latin typeface="Arial"/>
                <a:cs typeface="Arial"/>
              </a:rPr>
              <a:t>Process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05831" y="2941680"/>
            <a:ext cx="2828524" cy="938719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GB" sz="1100" dirty="0">
                <a:latin typeface="Arial"/>
                <a:cs typeface="Arial"/>
              </a:rPr>
              <a:t>Time-related notifications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Better </a:t>
            </a:r>
            <a:r>
              <a:rPr lang="en-GB" sz="1100" dirty="0" smtClean="0">
                <a:latin typeface="Arial"/>
                <a:cs typeface="Arial"/>
              </a:rPr>
              <a:t>digitalization </a:t>
            </a:r>
            <a:r>
              <a:rPr lang="en-GB" sz="1100" dirty="0">
                <a:latin typeface="Arial"/>
                <a:cs typeface="Arial"/>
              </a:rPr>
              <a:t>of hospital records, allowing decreased administration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Access to electronic health records and rapid referral pathways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896151" y="1775617"/>
            <a:ext cx="1997044" cy="26161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GB" sz="1100" dirty="0">
                <a:latin typeface="Arial"/>
                <a:cs typeface="Arial"/>
              </a:rPr>
              <a:t>Diagnostic apps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593981" y="665259"/>
            <a:ext cx="2725773" cy="769441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GB" sz="1100" dirty="0">
                <a:latin typeface="Arial"/>
                <a:cs typeface="Arial"/>
              </a:rPr>
              <a:t>Patient apps and digital technologies to reduce time for training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Limited opportunities for education, including CME</a:t>
            </a:r>
          </a:p>
        </p:txBody>
      </p:sp>
      <p:sp>
        <p:nvSpPr>
          <p:cNvPr id="12" name="Oval 11"/>
          <p:cNvSpPr>
            <a:spLocks noChangeAspect="1"/>
          </p:cNvSpPr>
          <p:nvPr/>
        </p:nvSpPr>
        <p:spPr>
          <a:xfrm>
            <a:off x="7481936" y="1877621"/>
            <a:ext cx="1080000" cy="108000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>
                <a:solidFill>
                  <a:srgbClr val="000000"/>
                </a:solidFill>
                <a:latin typeface="Arial"/>
                <a:cs typeface="Arial"/>
              </a:rPr>
              <a:t>Clinical/ Diagnostic</a:t>
            </a:r>
          </a:p>
        </p:txBody>
      </p:sp>
      <p:sp>
        <p:nvSpPr>
          <p:cNvPr id="13" name="Oval 12"/>
          <p:cNvSpPr>
            <a:spLocks noChangeAspect="1"/>
          </p:cNvSpPr>
          <p:nvPr/>
        </p:nvSpPr>
        <p:spPr>
          <a:xfrm>
            <a:off x="7481937" y="3176576"/>
            <a:ext cx="1080000" cy="108000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>
                <a:solidFill>
                  <a:srgbClr val="000000"/>
                </a:solidFill>
                <a:latin typeface="Arial"/>
                <a:cs typeface="Arial"/>
              </a:rPr>
              <a:t>Process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8742271" y="2766858"/>
            <a:ext cx="2762712" cy="1446550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GB" sz="1100" dirty="0">
                <a:latin typeface="Arial"/>
                <a:cs typeface="Arial"/>
              </a:rPr>
              <a:t>Lack of time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Logistics of forms, administration and communication that could be </a:t>
            </a:r>
            <a:r>
              <a:rPr lang="en-GB" sz="1100" dirty="0" smtClean="0">
                <a:latin typeface="Arial"/>
                <a:cs typeface="Arial"/>
              </a:rPr>
              <a:t>digitalized</a:t>
            </a:r>
            <a:endParaRPr lang="en-GB" sz="1100" dirty="0">
              <a:latin typeface="Arial"/>
              <a:cs typeface="Arial"/>
            </a:endParaRP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Nurse awareness of referral pathway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Lack of definition of responsibilities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No </a:t>
            </a:r>
            <a:r>
              <a:rPr lang="en-GB" sz="1100" dirty="0" smtClean="0">
                <a:latin typeface="Arial"/>
                <a:cs typeface="Arial"/>
              </a:rPr>
              <a:t>standardized </a:t>
            </a:r>
            <a:r>
              <a:rPr lang="en-GB" sz="1100" dirty="0">
                <a:latin typeface="Arial"/>
                <a:cs typeface="Arial"/>
              </a:rPr>
              <a:t>materials for communication with patients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Lack of tools for home training of patients</a:t>
            </a:r>
          </a:p>
        </p:txBody>
      </p:sp>
      <p:sp>
        <p:nvSpPr>
          <p:cNvPr id="16" name="Oval 15"/>
          <p:cNvSpPr>
            <a:spLocks noChangeAspect="1"/>
          </p:cNvSpPr>
          <p:nvPr/>
        </p:nvSpPr>
        <p:spPr>
          <a:xfrm>
            <a:off x="6539097" y="4627824"/>
            <a:ext cx="1080000" cy="1080000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>
                <a:solidFill>
                  <a:srgbClr val="000000"/>
                </a:solidFill>
                <a:latin typeface="Arial"/>
                <a:cs typeface="Arial"/>
              </a:rPr>
              <a:t>Education</a:t>
            </a:r>
          </a:p>
        </p:txBody>
      </p:sp>
      <p:sp>
        <p:nvSpPr>
          <p:cNvPr id="18" name="Oval 17"/>
          <p:cNvSpPr>
            <a:spLocks noChangeAspect="1"/>
          </p:cNvSpPr>
          <p:nvPr/>
        </p:nvSpPr>
        <p:spPr>
          <a:xfrm>
            <a:off x="4076162" y="4935727"/>
            <a:ext cx="1080000" cy="1080000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>
                <a:solidFill>
                  <a:srgbClr val="000000"/>
                </a:solidFill>
                <a:latin typeface="Arial"/>
                <a:cs typeface="Arial"/>
              </a:rPr>
              <a:t>Process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19604" y="4861135"/>
            <a:ext cx="3355685" cy="1277273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GB" sz="1100" dirty="0">
                <a:latin typeface="Arial"/>
                <a:cs typeface="Arial"/>
              </a:rPr>
              <a:t>Availability and access to electronic health records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Online secure communication platform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Distraction tools to aid blood taking and injections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Remote communication and addressing patient issues between visits 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System for electronic referral 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Remote monitoring of patients 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7971072" y="5185998"/>
            <a:ext cx="2974370" cy="261610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GB" sz="1100" dirty="0">
                <a:latin typeface="Arial"/>
                <a:cs typeface="Arial"/>
              </a:rPr>
              <a:t>Online platforms to learn about growth failure</a:t>
            </a:r>
          </a:p>
        </p:txBody>
      </p:sp>
      <p:sp>
        <p:nvSpPr>
          <p:cNvPr id="22" name="Oval 21"/>
          <p:cNvSpPr>
            <a:spLocks noChangeAspect="1"/>
          </p:cNvSpPr>
          <p:nvPr/>
        </p:nvSpPr>
        <p:spPr>
          <a:xfrm>
            <a:off x="6470178" y="1135185"/>
            <a:ext cx="1080000" cy="108000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 dirty="0">
                <a:solidFill>
                  <a:srgbClr val="000000"/>
                </a:solidFill>
                <a:latin typeface="Arial"/>
                <a:cs typeface="Arial"/>
              </a:rPr>
              <a:t>Education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7873331" y="748758"/>
            <a:ext cx="2762712" cy="76944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GB" sz="1100" dirty="0">
                <a:latin typeface="Arial"/>
                <a:cs typeface="Arial"/>
              </a:rPr>
              <a:t>Lack of knowledge about the referral and diagnostic pathways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Lack of knowledge of disease nature and consequences</a:t>
            </a:r>
          </a:p>
        </p:txBody>
      </p:sp>
      <p:cxnSp>
        <p:nvCxnSpPr>
          <p:cNvPr id="24" name="Straight Connector 23"/>
          <p:cNvCxnSpPr/>
          <p:nvPr/>
        </p:nvCxnSpPr>
        <p:spPr>
          <a:xfrm flipH="1">
            <a:off x="5111304" y="5118899"/>
            <a:ext cx="240530" cy="125077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>
            <a:stCxn id="21" idx="1"/>
          </p:cNvCxnSpPr>
          <p:nvPr/>
        </p:nvCxnSpPr>
        <p:spPr>
          <a:xfrm flipH="1" flipV="1">
            <a:off x="7586227" y="5298832"/>
            <a:ext cx="384845" cy="17971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 flipH="1">
            <a:off x="7475281" y="1041278"/>
            <a:ext cx="400807" cy="35732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/>
          <p:cNvCxnSpPr>
            <a:stCxn id="11" idx="3"/>
          </p:cNvCxnSpPr>
          <p:nvPr/>
        </p:nvCxnSpPr>
        <p:spPr>
          <a:xfrm>
            <a:off x="4319754" y="1049980"/>
            <a:ext cx="253302" cy="34862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0" name="Oval 49"/>
          <p:cNvSpPr>
            <a:spLocks noChangeAspect="1"/>
          </p:cNvSpPr>
          <p:nvPr/>
        </p:nvSpPr>
        <p:spPr>
          <a:xfrm>
            <a:off x="5261721" y="5537201"/>
            <a:ext cx="1080000" cy="1080000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 dirty="0">
                <a:solidFill>
                  <a:srgbClr val="000000"/>
                </a:solidFill>
                <a:latin typeface="Arial"/>
                <a:cs typeface="Arial"/>
              </a:rPr>
              <a:t>Clinical/ Diagnostics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6710517" y="6044910"/>
            <a:ext cx="2974370" cy="261610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GB" sz="1100" dirty="0">
                <a:latin typeface="Arial"/>
                <a:cs typeface="Arial"/>
              </a:rPr>
              <a:t>Digital monitoring of height and bone age</a:t>
            </a:r>
          </a:p>
        </p:txBody>
      </p:sp>
      <p:cxnSp>
        <p:nvCxnSpPr>
          <p:cNvPr id="52" name="Straight Connector 51"/>
          <p:cNvCxnSpPr>
            <a:stCxn id="51" idx="1"/>
          </p:cNvCxnSpPr>
          <p:nvPr/>
        </p:nvCxnSpPr>
        <p:spPr>
          <a:xfrm flipH="1" flipV="1">
            <a:off x="6325672" y="6157744"/>
            <a:ext cx="384845" cy="17971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902364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22</TotalTime>
  <Words>166</Words>
  <Application>Microsoft Macintosh PowerPoint</Application>
  <PresentationFormat>Custom</PresentationFormat>
  <Paragraphs>3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rat Bagha</dc:creator>
  <cp:lastModifiedBy>Peter Bates</cp:lastModifiedBy>
  <cp:revision>128</cp:revision>
  <dcterms:created xsi:type="dcterms:W3CDTF">2020-06-30T04:52:24Z</dcterms:created>
  <dcterms:modified xsi:type="dcterms:W3CDTF">2021-01-26T13:17:55Z</dcterms:modified>
</cp:coreProperties>
</file>